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4" d="100"/>
          <a:sy n="54" d="100"/>
        </p:scale>
        <p:origin x="9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3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81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8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081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37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297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31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663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91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245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936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BABC8-C59E-4E4D-95F9-AED5FC556D5B}" type="datetimeFigureOut">
              <a:rPr lang="en-US" smtClean="0"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C7AF9-4A74-46C5-9BD3-D509C97D97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007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8.jp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885CA6B-EC38-4041-8062-A2FEAC0DB7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2375361"/>
              </p:ext>
            </p:extLst>
          </p:nvPr>
        </p:nvGraphicFramePr>
        <p:xfrm>
          <a:off x="847725" y="1357783"/>
          <a:ext cx="3448050" cy="3319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6" r:id="rId3" imgW="3448660" imgH="3319180" progId="Prism6.Document">
                  <p:embed/>
                </p:oleObj>
              </mc:Choice>
              <mc:Fallback>
                <p:oleObj name="Prism 6" r:id="rId3" imgW="3448660" imgH="3319180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9896041-921F-4520-9B2D-3C4A2DB68D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7725" y="1357783"/>
                        <a:ext cx="3448050" cy="3319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9F2089B-53F1-4552-B26D-AB208FCB0D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1871906"/>
              </p:ext>
            </p:extLst>
          </p:nvPr>
        </p:nvGraphicFramePr>
        <p:xfrm>
          <a:off x="4438652" y="1357783"/>
          <a:ext cx="3457575" cy="3319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6" r:id="rId5" imgW="3457663" imgH="3319180" progId="Prism6.Document">
                  <p:embed/>
                </p:oleObj>
              </mc:Choice>
              <mc:Fallback>
                <p:oleObj name="Prism 6" r:id="rId5" imgW="3457663" imgH="3319180" progId="Prism6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1E11843-E8C8-47A0-BF1C-B0C6D0863A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38652" y="1357783"/>
                        <a:ext cx="3457575" cy="3319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AEE33D6-7978-4F04-85E1-9F4CE10FA1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3527522"/>
              </p:ext>
            </p:extLst>
          </p:nvPr>
        </p:nvGraphicFramePr>
        <p:xfrm>
          <a:off x="8096254" y="1357782"/>
          <a:ext cx="3448050" cy="3319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6" r:id="rId7" imgW="3448660" imgH="3319180" progId="Prism6.Document">
                  <p:embed/>
                </p:oleObj>
              </mc:Choice>
              <mc:Fallback>
                <p:oleObj name="Prism 6" r:id="rId7" imgW="3448660" imgH="3319180" progId="Prism6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1A365EE-1453-4F27-A00F-4DC0C83396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096254" y="1357782"/>
                        <a:ext cx="3448050" cy="3319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4D5994B-3551-417C-8B8E-0443C83F8D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5134177"/>
              </p:ext>
            </p:extLst>
          </p:nvPr>
        </p:nvGraphicFramePr>
        <p:xfrm>
          <a:off x="2709873" y="4542308"/>
          <a:ext cx="3448050" cy="3319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6" r:id="rId9" imgW="3448660" imgH="3319180" progId="Prism6.Document">
                  <p:embed/>
                </p:oleObj>
              </mc:Choice>
              <mc:Fallback>
                <p:oleObj name="Prism 6" r:id="rId9" imgW="3448660" imgH="3319180" progId="Prism6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7DDBE75-7E05-4B35-8B8D-33B8EAB901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709873" y="4542308"/>
                        <a:ext cx="3448050" cy="3319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9D90E86-273E-447E-A61D-2DC74E5672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4128439"/>
              </p:ext>
            </p:extLst>
          </p:nvPr>
        </p:nvGraphicFramePr>
        <p:xfrm>
          <a:off x="6372229" y="4542308"/>
          <a:ext cx="3448050" cy="3319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6" r:id="rId11" imgW="3448660" imgH="3319180" progId="Prism6.Document">
                  <p:embed/>
                </p:oleObj>
              </mc:Choice>
              <mc:Fallback>
                <p:oleObj name="Prism 6" r:id="rId11" imgW="3448660" imgH="3319180" progId="Prism6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F572495-9602-40C6-941B-CD9D14D9BF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72229" y="4542308"/>
                        <a:ext cx="3448050" cy="3319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E2282D8-5564-4987-A837-D3DCE7D0AFD6}"/>
              </a:ext>
            </a:extLst>
          </p:cNvPr>
          <p:cNvCxnSpPr>
            <a:cxnSpLocks/>
          </p:cNvCxnSpPr>
          <p:nvPr/>
        </p:nvCxnSpPr>
        <p:spPr>
          <a:xfrm>
            <a:off x="2199950" y="1645307"/>
            <a:ext cx="12371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E6BF6F9-9F0B-45C9-A03A-211CB5D5A28A}"/>
              </a:ext>
            </a:extLst>
          </p:cNvPr>
          <p:cNvSpPr txBox="1"/>
          <p:nvPr/>
        </p:nvSpPr>
        <p:spPr>
          <a:xfrm>
            <a:off x="2630257" y="13352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AD80EE-8965-46C4-B172-7D44B4823171}"/>
              </a:ext>
            </a:extLst>
          </p:cNvPr>
          <p:cNvSpPr txBox="1"/>
          <p:nvPr/>
        </p:nvSpPr>
        <p:spPr>
          <a:xfrm>
            <a:off x="1401062" y="1206863"/>
            <a:ext cx="789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WIST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5F679C0-4F93-4E08-A4D9-823AD76A9EB1}"/>
              </a:ext>
            </a:extLst>
          </p:cNvPr>
          <p:cNvCxnSpPr>
            <a:cxnSpLocks/>
          </p:cNvCxnSpPr>
          <p:nvPr/>
        </p:nvCxnSpPr>
        <p:spPr>
          <a:xfrm>
            <a:off x="5832150" y="1645307"/>
            <a:ext cx="12371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032783CD-8D9B-4A19-BB5C-91FE8E95DA04}"/>
              </a:ext>
            </a:extLst>
          </p:cNvPr>
          <p:cNvSpPr txBox="1"/>
          <p:nvPr/>
        </p:nvSpPr>
        <p:spPr>
          <a:xfrm>
            <a:off x="6262457" y="13352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s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707FE8F-0162-4B8D-A198-EBBC23414908}"/>
              </a:ext>
            </a:extLst>
          </p:cNvPr>
          <p:cNvCxnSpPr>
            <a:cxnSpLocks/>
          </p:cNvCxnSpPr>
          <p:nvPr/>
        </p:nvCxnSpPr>
        <p:spPr>
          <a:xfrm>
            <a:off x="9451650" y="1645307"/>
            <a:ext cx="12371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FB88636-E58B-48FB-A3C8-BC91E2C14C9B}"/>
              </a:ext>
            </a:extLst>
          </p:cNvPr>
          <p:cNvSpPr txBox="1"/>
          <p:nvPr/>
        </p:nvSpPr>
        <p:spPr>
          <a:xfrm>
            <a:off x="9881957" y="13352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690C9FC-683A-48CA-BED1-EADF37B10804}"/>
              </a:ext>
            </a:extLst>
          </p:cNvPr>
          <p:cNvCxnSpPr>
            <a:cxnSpLocks/>
          </p:cNvCxnSpPr>
          <p:nvPr/>
        </p:nvCxnSpPr>
        <p:spPr>
          <a:xfrm>
            <a:off x="7775250" y="4794907"/>
            <a:ext cx="12371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63810C7-B7B4-4D52-A462-374BF66D09AB}"/>
              </a:ext>
            </a:extLst>
          </p:cNvPr>
          <p:cNvSpPr txBox="1"/>
          <p:nvPr/>
        </p:nvSpPr>
        <p:spPr>
          <a:xfrm>
            <a:off x="8205557" y="44848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s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67DE0C8-3CC7-446C-B9B9-E373EB1A5289}"/>
              </a:ext>
            </a:extLst>
          </p:cNvPr>
          <p:cNvCxnSpPr>
            <a:cxnSpLocks/>
          </p:cNvCxnSpPr>
          <p:nvPr/>
        </p:nvCxnSpPr>
        <p:spPr>
          <a:xfrm>
            <a:off x="4104950" y="4947307"/>
            <a:ext cx="12371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5856811-DE02-4EA0-876D-8B906E2340DF}"/>
              </a:ext>
            </a:extLst>
          </p:cNvPr>
          <p:cNvSpPr txBox="1"/>
          <p:nvPr/>
        </p:nvSpPr>
        <p:spPr>
          <a:xfrm>
            <a:off x="4471757" y="470078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C6577B-ED94-45CB-A3D6-ABA44C715DB1}"/>
              </a:ext>
            </a:extLst>
          </p:cNvPr>
          <p:cNvSpPr txBox="1"/>
          <p:nvPr/>
        </p:nvSpPr>
        <p:spPr>
          <a:xfrm>
            <a:off x="5011136" y="1206863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NAI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4605BC7-C3E8-47A9-B100-DE438B5D7C47}"/>
              </a:ext>
            </a:extLst>
          </p:cNvPr>
          <p:cNvSpPr txBox="1"/>
          <p:nvPr/>
        </p:nvSpPr>
        <p:spPr>
          <a:xfrm>
            <a:off x="8624799" y="1206863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NAI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FFE8EB6-C4B7-4683-B807-4B25A4E8D094}"/>
              </a:ext>
            </a:extLst>
          </p:cNvPr>
          <p:cNvSpPr txBox="1"/>
          <p:nvPr/>
        </p:nvSpPr>
        <p:spPr>
          <a:xfrm>
            <a:off x="3310857" y="4442945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ZEB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45A3E0C-2C7F-4E62-9EF8-FAC74AEF4AED}"/>
              </a:ext>
            </a:extLst>
          </p:cNvPr>
          <p:cNvSpPr txBox="1"/>
          <p:nvPr/>
        </p:nvSpPr>
        <p:spPr>
          <a:xfrm>
            <a:off x="6978613" y="4442945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ZEB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949B38B-B6B6-4FDC-9DD7-CBF4B76B8DC7}"/>
              </a:ext>
            </a:extLst>
          </p:cNvPr>
          <p:cNvSpPr txBox="1"/>
          <p:nvPr/>
        </p:nvSpPr>
        <p:spPr>
          <a:xfrm>
            <a:off x="-1" y="0"/>
            <a:ext cx="3021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3FD32E-FF08-4053-86DB-739F4EDE4F66}"/>
              </a:ext>
            </a:extLst>
          </p:cNvPr>
          <p:cNvSpPr txBox="1"/>
          <p:nvPr/>
        </p:nvSpPr>
        <p:spPr>
          <a:xfrm>
            <a:off x="616533" y="728325"/>
            <a:ext cx="784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BA21D74-CA93-4B08-A83C-10D53F7DAC04}"/>
              </a:ext>
            </a:extLst>
          </p:cNvPr>
          <p:cNvSpPr txBox="1"/>
          <p:nvPr/>
        </p:nvSpPr>
        <p:spPr>
          <a:xfrm>
            <a:off x="616533" y="8092014"/>
            <a:ext cx="784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1C81F71-BEC4-4944-A6F6-B2C14239ACB9}"/>
              </a:ext>
            </a:extLst>
          </p:cNvPr>
          <p:cNvGrpSpPr/>
          <p:nvPr/>
        </p:nvGrpSpPr>
        <p:grpSpPr>
          <a:xfrm>
            <a:off x="6172204" y="9389672"/>
            <a:ext cx="3648075" cy="3400425"/>
            <a:chOff x="6630144" y="9001627"/>
            <a:chExt cx="3648075" cy="3400425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DE0F2B4-C5A8-4AE9-95F7-F4607257DCF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630144" y="9001627"/>
              <a:ext cx="3648075" cy="3400425"/>
            </a:xfrm>
            <a:prstGeom prst="rect">
              <a:avLst/>
            </a:prstGeom>
          </p:spPr>
        </p:pic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88C3ED8-51D7-403F-A24C-7C5DABA68DE2}"/>
                </a:ext>
              </a:extLst>
            </p:cNvPr>
            <p:cNvCxnSpPr>
              <a:cxnSpLocks/>
            </p:cNvCxnSpPr>
            <p:nvPr/>
          </p:nvCxnSpPr>
          <p:spPr>
            <a:xfrm>
              <a:off x="8099583" y="9590488"/>
              <a:ext cx="123713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FC41C92-252F-4FD7-BAD1-61B8396EF85F}"/>
                </a:ext>
              </a:extLst>
            </p:cNvPr>
            <p:cNvSpPr txBox="1"/>
            <p:nvPr/>
          </p:nvSpPr>
          <p:spPr>
            <a:xfrm>
              <a:off x="8529890" y="9280468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s</a:t>
              </a:r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9CA8E96A-D61D-4255-94C4-CBEF24CA3DF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646" y="8740187"/>
            <a:ext cx="2630257" cy="197920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DA19CED-7EDD-44D3-8A52-041BB3B673D2}"/>
              </a:ext>
            </a:extLst>
          </p:cNvPr>
          <p:cNvSpPr txBox="1"/>
          <p:nvPr/>
        </p:nvSpPr>
        <p:spPr>
          <a:xfrm rot="16200000">
            <a:off x="2060691" y="9498055"/>
            <a:ext cx="15157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Mimi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B2F4675-02AA-4C22-A8D4-19503DDACF7C}"/>
              </a:ext>
            </a:extLst>
          </p:cNvPr>
          <p:cNvSpPr txBox="1"/>
          <p:nvPr/>
        </p:nvSpPr>
        <p:spPr>
          <a:xfrm rot="16200000">
            <a:off x="2005163" y="11747528"/>
            <a:ext cx="13497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ubcluster A</a:t>
            </a:r>
          </a:p>
          <a:p>
            <a:pPr algn="ctr"/>
            <a:r>
              <a:rPr lang="en-US" dirty="0"/>
              <a:t>Mimic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BE348FA7-08AD-4E6E-A4D8-2FFD5694B8E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3225" y="10827884"/>
            <a:ext cx="2607678" cy="1962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3772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1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era Nanjundan</dc:creator>
  <cp:lastModifiedBy>Meera Nanjundan</cp:lastModifiedBy>
  <cp:revision>4</cp:revision>
  <dcterms:created xsi:type="dcterms:W3CDTF">2022-11-02T20:30:16Z</dcterms:created>
  <dcterms:modified xsi:type="dcterms:W3CDTF">2022-11-02T20:35:28Z</dcterms:modified>
</cp:coreProperties>
</file>